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51048-F41F-4AA8-8D1C-242C13CB91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B94B4-C74A-4B9E-B203-F7BA762FA8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D3FD9-D650-4768-A5B3-42711C0F4A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43FC8-BE58-4E00-B9DD-36CD589A11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3D16B-361A-4E66-A66A-76D56BEDF5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D048E-FF3D-4497-BC7A-CB8382DD87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EBAD5-8E14-4D26-9648-8744B5E345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8C0D2-636E-4D40-AA7A-AFE80E0912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A2EA4-EA1B-44BD-BA66-D944660C4B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B57F1-0E9C-41AA-8726-4143C9060E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DFAD8-AE87-42FC-BF94-2C3DF9DF4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7CCE7-E5DE-484B-82DF-7BD7BE7183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7000"/>
          </a:bodyPr>
          <a:p>
            <a:pPr marL="298440" indent="-29844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46200" indent="-2484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94320" indent="-19872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92120" indent="-19872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71E14F-8A43-4C10-B496-DB6D4C35255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5480" y="3833640"/>
            <a:ext cx="5745240" cy="174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Additional file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Hybridization intensity maps for genes identified in Figure 3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"/>
          <p:cNvGrpSpPr/>
          <p:nvPr/>
        </p:nvGrpSpPr>
        <p:grpSpPr>
          <a:xfrm>
            <a:off x="330120" y="1828800"/>
            <a:ext cx="6097680" cy="4572000"/>
            <a:chOff x="330120" y="1828800"/>
            <a:chExt cx="6097680" cy="4572000"/>
          </a:xfrm>
        </p:grpSpPr>
        <p:pic>
          <p:nvPicPr>
            <p:cNvPr id="82" name="" descr=""/>
            <p:cNvPicPr/>
            <p:nvPr/>
          </p:nvPicPr>
          <p:blipFill>
            <a:blip r:embed="rId1"/>
            <a:stretch/>
          </p:blipFill>
          <p:spPr>
            <a:xfrm>
              <a:off x="33012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"/>
            <p:cNvSpPr/>
            <p:nvPr/>
          </p:nvSpPr>
          <p:spPr>
            <a:xfrm>
              <a:off x="2913120" y="5027760"/>
              <a:ext cx="1193760" cy="91440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4266720" y="22208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587680" y="22208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"/>
          <p:cNvGrpSpPr/>
          <p:nvPr/>
        </p:nvGrpSpPr>
        <p:grpSpPr>
          <a:xfrm>
            <a:off x="382680" y="1828800"/>
            <a:ext cx="6097320" cy="4572000"/>
            <a:chOff x="382680" y="1828800"/>
            <a:chExt cx="6097320" cy="4572000"/>
          </a:xfrm>
        </p:grpSpPr>
        <p:pic>
          <p:nvPicPr>
            <p:cNvPr id="87" name="" descr=""/>
            <p:cNvPicPr/>
            <p:nvPr/>
          </p:nvPicPr>
          <p:blipFill>
            <a:blip r:embed="rId1"/>
            <a:stretch/>
          </p:blipFill>
          <p:spPr>
            <a:xfrm>
              <a:off x="382680" y="1828800"/>
              <a:ext cx="609732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 flipH="1">
              <a:off x="5003280" y="221616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813120" y="221472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 flipH="1">
              <a:off x="4158360" y="5029200"/>
              <a:ext cx="59076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"/>
          <p:cNvGrpSpPr/>
          <p:nvPr/>
        </p:nvGrpSpPr>
        <p:grpSpPr>
          <a:xfrm>
            <a:off x="417600" y="1828800"/>
            <a:ext cx="6097680" cy="4572000"/>
            <a:chOff x="417600" y="1828800"/>
            <a:chExt cx="6097680" cy="4572000"/>
          </a:xfrm>
        </p:grpSpPr>
        <p:pic>
          <p:nvPicPr>
            <p:cNvPr id="92" name="" descr=""/>
            <p:cNvPicPr/>
            <p:nvPr/>
          </p:nvPicPr>
          <p:blipFill>
            <a:blip r:embed="rId1"/>
            <a:stretch/>
          </p:blipFill>
          <p:spPr>
            <a:xfrm>
              <a:off x="41760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 flipH="1">
              <a:off x="3464640" y="5029200"/>
              <a:ext cx="31140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 flipH="1">
              <a:off x="3793680" y="222408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976480" y="222408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" descr=""/>
          <p:cNvPicPr/>
          <p:nvPr/>
        </p:nvPicPr>
        <p:blipFill>
          <a:blip r:embed="rId1"/>
          <a:stretch/>
        </p:blipFill>
        <p:spPr>
          <a:xfrm>
            <a:off x="593640" y="1754280"/>
            <a:ext cx="6234120" cy="467496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 flipH="1">
            <a:off x="2481120" y="5038560"/>
            <a:ext cx="1581120" cy="91620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427320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29716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598320" y="1754280"/>
            <a:ext cx="6235920" cy="4674960"/>
          </a:xfrm>
          <a:prstGeom prst="rect">
            <a:avLst/>
          </a:prstGeom>
          <a:ln w="0">
            <a:noFill/>
          </a:ln>
        </p:spPr>
      </p:pic>
      <p:sp>
        <p:nvSpPr>
          <p:cNvPr id="101" name=""/>
          <p:cNvSpPr/>
          <p:nvPr/>
        </p:nvSpPr>
        <p:spPr>
          <a:xfrm flipH="1">
            <a:off x="2490120" y="5038560"/>
            <a:ext cx="1571400" cy="91620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 flipH="1">
            <a:off x="427320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29716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"/>
          <p:cNvGrpSpPr/>
          <p:nvPr/>
        </p:nvGrpSpPr>
        <p:grpSpPr>
          <a:xfrm>
            <a:off x="399960" y="1828800"/>
            <a:ext cx="6097680" cy="4572000"/>
            <a:chOff x="399960" y="1828800"/>
            <a:chExt cx="6097680" cy="457200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39996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 flipH="1">
              <a:off x="2320920" y="5037120"/>
              <a:ext cx="154080" cy="90648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 flipH="1">
              <a:off x="2553840" y="222876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168640" y="2228760"/>
              <a:ext cx="12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431640" y="1584360"/>
            <a:ext cx="6426360" cy="48178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4191120" y="4954680"/>
            <a:ext cx="109440" cy="97308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062240" y="2006640"/>
            <a:ext cx="136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4317840" y="2006640"/>
            <a:ext cx="136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311040" y="1627200"/>
            <a:ext cx="6310440" cy="473076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836880" y="2031840"/>
            <a:ext cx="1684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4565520" y="2031840"/>
            <a:ext cx="1684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302000" y="4944960"/>
            <a:ext cx="142920" cy="93996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2587680" y="2014560"/>
            <a:ext cx="596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DM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393840" y="1819440"/>
            <a:ext cx="6094440" cy="457020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 flipH="1">
            <a:off x="2379600" y="5016600"/>
            <a:ext cx="1782720" cy="90648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flipH="1">
            <a:off x="4188960" y="222732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1825560" y="222732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624040" y="2075040"/>
            <a:ext cx="38124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548080" y="2008080"/>
            <a:ext cx="56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DM2,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"/>
          <p:cNvGrpSpPr/>
          <p:nvPr/>
        </p:nvGrpSpPr>
        <p:grpSpPr>
          <a:xfrm>
            <a:off x="295200" y="1846440"/>
            <a:ext cx="6097680" cy="4572000"/>
            <a:chOff x="295200" y="1846440"/>
            <a:chExt cx="6097680" cy="4572000"/>
          </a:xfrm>
        </p:grpSpPr>
        <p:pic>
          <p:nvPicPr>
            <p:cNvPr id="63" name="" descr=""/>
            <p:cNvPicPr/>
            <p:nvPr/>
          </p:nvPicPr>
          <p:blipFill>
            <a:blip r:embed="rId1"/>
            <a:stretch/>
          </p:blipFill>
          <p:spPr>
            <a:xfrm>
              <a:off x="295200" y="184644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"/>
            <p:cNvSpPr/>
            <p:nvPr/>
          </p:nvSpPr>
          <p:spPr>
            <a:xfrm flipH="1">
              <a:off x="2490840" y="5046840"/>
              <a:ext cx="1379520" cy="90612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>
              <a:off x="448596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94148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"/>
          <p:cNvGrpSpPr/>
          <p:nvPr/>
        </p:nvGrpSpPr>
        <p:grpSpPr>
          <a:xfrm>
            <a:off x="495360" y="1828800"/>
            <a:ext cx="6094440" cy="4570560"/>
            <a:chOff x="495360" y="1828800"/>
            <a:chExt cx="6094440" cy="4570560"/>
          </a:xfrm>
        </p:grpSpPr>
        <p:pic>
          <p:nvPicPr>
            <p:cNvPr id="68" name="" descr=""/>
            <p:cNvPicPr/>
            <p:nvPr/>
          </p:nvPicPr>
          <p:blipFill>
            <a:blip r:embed="rId1"/>
            <a:stretch/>
          </p:blipFill>
          <p:spPr>
            <a:xfrm>
              <a:off x="495360" y="1828800"/>
              <a:ext cx="6094440" cy="457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 flipH="1">
              <a:off x="319212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74312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 flipH="1">
              <a:off x="1916280" y="5029200"/>
              <a:ext cx="203040" cy="90648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"/>
          <p:cNvSpPr/>
          <p:nvPr/>
        </p:nvSpPr>
        <p:spPr>
          <a:xfrm>
            <a:off x="2549520" y="2014560"/>
            <a:ext cx="674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N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3" name=""/>
          <p:cNvGrpSpPr/>
          <p:nvPr/>
        </p:nvGrpSpPr>
        <p:grpSpPr>
          <a:xfrm>
            <a:off x="495360" y="1828800"/>
            <a:ext cx="6094440" cy="4570560"/>
            <a:chOff x="495360" y="1828800"/>
            <a:chExt cx="6094440" cy="4570560"/>
          </a:xfrm>
        </p:grpSpPr>
        <p:pic>
          <p:nvPicPr>
            <p:cNvPr id="74" name="" descr=""/>
            <p:cNvPicPr/>
            <p:nvPr/>
          </p:nvPicPr>
          <p:blipFill>
            <a:blip r:embed="rId1"/>
            <a:stretch/>
          </p:blipFill>
          <p:spPr>
            <a:xfrm>
              <a:off x="495360" y="1828800"/>
              <a:ext cx="6094440" cy="457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 flipH="1">
              <a:off x="2830680" y="5038560"/>
              <a:ext cx="109440" cy="90648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06840" y="2225520"/>
              <a:ext cx="12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2928600" y="222732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8" name=""/>
          <p:cNvSpPr/>
          <p:nvPr/>
        </p:nvSpPr>
        <p:spPr>
          <a:xfrm>
            <a:off x="2548080" y="2082960"/>
            <a:ext cx="736560" cy="91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2662200" y="200988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C,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"/>
          <p:cNvSpPr/>
          <p:nvPr/>
        </p:nvSpPr>
        <p:spPr>
          <a:xfrm>
            <a:off x="555480" y="4160880"/>
            <a:ext cx="57452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Hybridization intensity maps for genes identified in Figure 3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6T17:22:47Z</dcterms:created>
  <dc:creator>UT M.D. Anderson</dc:creator>
  <dc:description/>
  <dc:language>en-US</dc:language>
  <cp:lastModifiedBy>Ralf Krahe, Ph.D.</cp:lastModifiedBy>
  <cp:lastPrinted>2007-01-31T17:26:47Z</cp:lastPrinted>
  <dcterms:modified xsi:type="dcterms:W3CDTF">2008-03-05T01:05:02Z</dcterms:modified>
  <cp:revision>89</cp:revision>
  <dc:subject/>
  <dc:title>PowerPoint Presentation</dc:title>
</cp:coreProperties>
</file>